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288588" cy="6858000"/>
  <p:notesSz cx="9867900" cy="67357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867600" cy="6735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4275000" cy="37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590800" y="-360"/>
            <a:ext cx="4275000" cy="37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3024000" y="523440"/>
            <a:ext cx="3817800" cy="25448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1315800" y="3218040"/>
            <a:ext cx="7234200" cy="29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59080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Times New Roman"/>
                <a:ea typeface="中ゴシックＢＢＢ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4706D4-5B31-4964-906E-4DC0E6E006CC}" type="slidenum">
              <a:rPr b="1" lang="en-US" sz="1200" spc="-1" strike="noStrike">
                <a:solidFill>
                  <a:srgbClr val="000000"/>
                </a:solidFill>
                <a:latin typeface="Times New Roman"/>
                <a:ea typeface="中ゴシックＢＢＢ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3024360" y="523800"/>
            <a:ext cx="3817800" cy="254484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1315800" y="3218040"/>
            <a:ext cx="7234200" cy="299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スライド番号プレースホルダー 3"/>
          <p:cNvSpPr/>
          <p:nvPr/>
        </p:nvSpPr>
        <p:spPr>
          <a:xfrm>
            <a:off x="559116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F35FB3-59CC-4EF4-B740-1964AEF3D5E2}" type="slidenum">
              <a:rPr b="1" lang="en-US" sz="1200" spc="-1" strike="noStrike">
                <a:solidFill>
                  <a:srgbClr val="ffffff"/>
                </a:solidFill>
                <a:latin typeface="Times New Roman"/>
                <a:ea typeface="中ゴシックＢＢＢ"/>
              </a:rPr>
              <a:t>&lt;number&gt;</a:t>
            </a:fld>
            <a:endParaRPr b="1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9C7204-9C2C-419C-AE1E-A546B4409C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71120" y="413064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04482-3E75-41BF-89A0-BF0CFF31F8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25204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162CD1-1FD1-43A0-B1EC-2E83E205C7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72744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8376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7112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72744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8376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BC640-97D8-4F5B-9939-56405D00BF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E4AA8-0C4C-42AE-ACCB-3F13F93976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26365-9134-4745-8A7A-6AF29FC06B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14D7C-FACA-4BEB-94BD-3F1992C1C7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94970-C98A-4B51-9E25-7C31996B97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71120" y="609120"/>
            <a:ext cx="874404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E1AD9A-5629-449D-8B60-BC20D31ED9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E25DD-4AA6-4458-BC41-6014302A73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25204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24F65-8BC1-44D5-AA8A-617DBB9627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259C51-B46C-479C-8428-3E2DF0B0E9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ffffff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ffffff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ffffff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ffffff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71120" y="6248520"/>
            <a:ext cx="2143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514320" y="6248520"/>
            <a:ext cx="32576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372080" y="6248520"/>
            <a:ext cx="2143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  <a:ea typeface="Osak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811127-D5B1-444C-8DE5-988D41B48E85}" type="slidenum">
              <a:rPr b="0" lang="en-US" sz="1400" spc="-1" strike="noStrike">
                <a:solidFill>
                  <a:srgbClr val="ffffff"/>
                </a:solidFill>
                <a:latin typeface="Times New Roman"/>
                <a:ea typeface="Osaka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27"/>
          <p:cNvSpPr/>
          <p:nvPr/>
        </p:nvSpPr>
        <p:spPr>
          <a:xfrm>
            <a:off x="1417680" y="752400"/>
            <a:ext cx="8089920" cy="825480"/>
          </a:xfrm>
          <a:prstGeom prst="rect">
            <a:avLst/>
          </a:prstGeom>
          <a:noFill/>
          <a:ln w="0">
            <a:noFill/>
          </a:ln>
          <a:effectLst>
            <a:outerShdw dist="17819" dir="2700000" blurRad="0" rotWithShape="0">
              <a:srgbClr val="00003d">
                <a:alpha val="7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Multivariate analysis of factors associated with RFS and DSS </a:t>
            </a: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9" name="Line 28"/>
          <p:cNvSpPr/>
          <p:nvPr/>
        </p:nvSpPr>
        <p:spPr>
          <a:xfrm>
            <a:off x="0" y="4902120"/>
            <a:ext cx="102870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0" name="Line 33"/>
          <p:cNvSpPr/>
          <p:nvPr/>
        </p:nvSpPr>
        <p:spPr>
          <a:xfrm>
            <a:off x="-30240" y="1316160"/>
            <a:ext cx="102870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1" name="Rectangle 55"/>
          <p:cNvSpPr/>
          <p:nvPr/>
        </p:nvSpPr>
        <p:spPr>
          <a:xfrm>
            <a:off x="36720" y="768240"/>
            <a:ext cx="1462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Table S4.</a:t>
            </a: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2" name="Line 34"/>
          <p:cNvSpPr/>
          <p:nvPr/>
        </p:nvSpPr>
        <p:spPr>
          <a:xfrm>
            <a:off x="12600" y="2532240"/>
            <a:ext cx="102870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3" name="Text Box 25"/>
          <p:cNvSpPr/>
          <p:nvPr/>
        </p:nvSpPr>
        <p:spPr>
          <a:xfrm>
            <a:off x="49320" y="2550960"/>
            <a:ext cx="4438440" cy="25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Age at surgery (</a:t>
            </a:r>
            <a:r>
              <a:rPr b="0" lang="ja-JP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＜</a:t>
            </a:r>
            <a:r>
              <a:rPr b="0" lang="en-US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 vs. </a:t>
            </a:r>
            <a:r>
              <a:rPr b="0" lang="ja-JP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≧</a:t>
            </a:r>
            <a:r>
              <a:rPr b="0" lang="en-US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)</a:t>
            </a:r>
            <a:endParaRPr b="1" lang="en-US" sz="20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Maximum pathological tumor stage</a:t>
            </a:r>
            <a:endParaRPr b="1" lang="en-US" sz="20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　</a:t>
            </a:r>
            <a:r>
              <a:rPr b="0" lang="en-US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(pT1 or less vs. pT2-4)</a:t>
            </a:r>
            <a:endParaRPr b="1" lang="en-US" sz="20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pN positive </a:t>
            </a:r>
            <a:endParaRPr b="1" lang="en-US" sz="20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CIS</a:t>
            </a:r>
            <a:endParaRPr b="1" lang="en-US" sz="20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UC grade</a:t>
            </a:r>
            <a:endParaRPr b="1" lang="en-US" sz="20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Urinary diversion form (IC or NB)</a:t>
            </a:r>
            <a:endParaRPr b="1" lang="en-US" sz="2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4" name="Rectangle 51"/>
          <p:cNvSpPr/>
          <p:nvPr/>
        </p:nvSpPr>
        <p:spPr>
          <a:xfrm>
            <a:off x="-46080" y="1714680"/>
            <a:ext cx="2352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Prognostic factors</a:t>
            </a:r>
            <a:endParaRPr b="1" lang="en-US" sz="2000" spc="-1" strike="noStrike">
              <a:solidFill>
                <a:srgbClr val="ffffff"/>
              </a:solidFill>
              <a:latin typeface="Times New Roman"/>
            </a:endParaRPr>
          </a:p>
        </p:txBody>
      </p:sp>
      <p:grpSp>
        <p:nvGrpSpPr>
          <p:cNvPr id="55" name="グループ化 2"/>
          <p:cNvGrpSpPr/>
          <p:nvPr/>
        </p:nvGrpSpPr>
        <p:grpSpPr>
          <a:xfrm>
            <a:off x="3895560" y="1434960"/>
            <a:ext cx="3140640" cy="3346200"/>
            <a:chOff x="3895560" y="1434960"/>
            <a:chExt cx="3140640" cy="3346200"/>
          </a:xfrm>
        </p:grpSpPr>
        <p:sp>
          <p:nvSpPr>
            <p:cNvPr id="56" name="Line 40"/>
            <p:cNvSpPr/>
            <p:nvPr/>
          </p:nvSpPr>
          <p:spPr>
            <a:xfrm>
              <a:off x="3895560" y="1917360"/>
              <a:ext cx="3078360" cy="9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7" name="Rectangle 48"/>
            <p:cNvSpPr/>
            <p:nvPr/>
          </p:nvSpPr>
          <p:spPr>
            <a:xfrm>
              <a:off x="5135400" y="1434960"/>
              <a:ext cx="9046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RFS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8" name="Rectangle 49"/>
            <p:cNvSpPr/>
            <p:nvPr/>
          </p:nvSpPr>
          <p:spPr>
            <a:xfrm>
              <a:off x="3909960" y="1996920"/>
              <a:ext cx="15962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RR (95</a:t>
              </a:r>
              <a:r>
                <a:rPr b="0" lang="ja-JP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％ </a:t>
              </a: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CI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9" name="Text Box 56"/>
            <p:cNvSpPr/>
            <p:nvPr/>
          </p:nvSpPr>
          <p:spPr>
            <a:xfrm>
              <a:off x="3947760" y="2552760"/>
              <a:ext cx="2205000" cy="222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.08 (1.01-1.17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19 (0.05-0.71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86 (12.4-2808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31 (0.03-3.29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.72 (0.43-6.88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.07 (0.61-7.07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0" name="Rectangle 49"/>
            <p:cNvSpPr/>
            <p:nvPr/>
          </p:nvSpPr>
          <p:spPr>
            <a:xfrm>
              <a:off x="5840280" y="1996920"/>
              <a:ext cx="1195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</a:t>
              </a: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Value*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1" name="Text Box 56"/>
            <p:cNvSpPr/>
            <p:nvPr/>
          </p:nvSpPr>
          <p:spPr>
            <a:xfrm>
              <a:off x="5892840" y="2552760"/>
              <a:ext cx="1081080" cy="222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03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01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0001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33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44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25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sp>
        <p:nvSpPr>
          <p:cNvPr id="62" name="Rectangle 44"/>
          <p:cNvSpPr/>
          <p:nvPr/>
        </p:nvSpPr>
        <p:spPr>
          <a:xfrm>
            <a:off x="5447160" y="4991040"/>
            <a:ext cx="4656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* Cox model for multivariate analysis.</a:t>
            </a:r>
            <a:endParaRPr b="1" lang="en-US" sz="2000" spc="-1" strike="noStrike">
              <a:solidFill>
                <a:srgbClr val="ffffff"/>
              </a:solidFill>
              <a:latin typeface="Times New Roman"/>
            </a:endParaRPr>
          </a:p>
        </p:txBody>
      </p:sp>
      <p:grpSp>
        <p:nvGrpSpPr>
          <p:cNvPr id="63" name="グループ化 3"/>
          <p:cNvGrpSpPr/>
          <p:nvPr/>
        </p:nvGrpSpPr>
        <p:grpSpPr>
          <a:xfrm>
            <a:off x="7078680" y="1434960"/>
            <a:ext cx="3140640" cy="3346200"/>
            <a:chOff x="7078680" y="1434960"/>
            <a:chExt cx="3140640" cy="3346200"/>
          </a:xfrm>
        </p:grpSpPr>
        <p:sp>
          <p:nvSpPr>
            <p:cNvPr id="64" name="Line 40"/>
            <p:cNvSpPr/>
            <p:nvPr/>
          </p:nvSpPr>
          <p:spPr>
            <a:xfrm>
              <a:off x="7078680" y="1917360"/>
              <a:ext cx="3078360" cy="93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5" name="Rectangle 48"/>
            <p:cNvSpPr/>
            <p:nvPr/>
          </p:nvSpPr>
          <p:spPr>
            <a:xfrm>
              <a:off x="8318520" y="1434960"/>
              <a:ext cx="9046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DSS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6" name="Rectangle 49"/>
            <p:cNvSpPr/>
            <p:nvPr/>
          </p:nvSpPr>
          <p:spPr>
            <a:xfrm>
              <a:off x="7093080" y="1996920"/>
              <a:ext cx="15962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RR (95</a:t>
              </a:r>
              <a:r>
                <a:rPr b="0" lang="ja-JP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％ </a:t>
              </a: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CI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7" name="Text Box 56"/>
            <p:cNvSpPr/>
            <p:nvPr/>
          </p:nvSpPr>
          <p:spPr>
            <a:xfrm>
              <a:off x="7130880" y="2552760"/>
              <a:ext cx="2205000" cy="222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.09 (1.03-1.18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43 (0.15-1.25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5.67 (1.17-27.48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68 (0.17-2.76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.48 (0.52-4.19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.05 (0.40-2.76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8" name="Rectangle 49"/>
            <p:cNvSpPr/>
            <p:nvPr/>
          </p:nvSpPr>
          <p:spPr>
            <a:xfrm>
              <a:off x="9023400" y="1996920"/>
              <a:ext cx="1195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</a:t>
              </a: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Value*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9" name="Text Box 56"/>
            <p:cNvSpPr/>
            <p:nvPr/>
          </p:nvSpPr>
          <p:spPr>
            <a:xfrm>
              <a:off x="9075960" y="2552760"/>
              <a:ext cx="846000" cy="222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006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12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03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58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46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91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0-05-10T06:54:23Z</dcterms:created>
  <dc:creator>pal</dc:creator>
  <dc:description/>
  <dc:language>en-US</dc:language>
  <cp:lastModifiedBy>NOZOMI HAYAKAWA</cp:lastModifiedBy>
  <cp:lastPrinted>2015-01-22T06:15:28Z</cp:lastPrinted>
  <dcterms:modified xsi:type="dcterms:W3CDTF">2015-08-05T00:20:46Z</dcterms:modified>
  <cp:revision>937</cp:revision>
  <dc:subject/>
  <dc:title>1501043</dc:title>
</cp:coreProperties>
</file>